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5" autoAdjust="0"/>
    <p:restoredTop sz="94660"/>
  </p:normalViewPr>
  <p:slideViewPr>
    <p:cSldViewPr snapToGrid="0">
      <p:cViewPr varScale="1">
        <p:scale>
          <a:sx n="72" d="100"/>
          <a:sy n="72" d="100"/>
        </p:scale>
        <p:origin x="576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ECB9C3-4A3F-4ECD-9596-22DD368FA6DE}" type="datetimeFigureOut">
              <a:rPr lang="en-US" smtClean="0"/>
              <a:t>3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B2100-0734-45BD-987A-45FB6FDA80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8652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ECB9C3-4A3F-4ECD-9596-22DD368FA6DE}" type="datetimeFigureOut">
              <a:rPr lang="en-US" smtClean="0"/>
              <a:t>3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B2100-0734-45BD-987A-45FB6FDA80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94248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ECB9C3-4A3F-4ECD-9596-22DD368FA6DE}" type="datetimeFigureOut">
              <a:rPr lang="en-US" smtClean="0"/>
              <a:t>3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B2100-0734-45BD-987A-45FB6FDA80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83568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ECB9C3-4A3F-4ECD-9596-22DD368FA6DE}" type="datetimeFigureOut">
              <a:rPr lang="en-US" smtClean="0"/>
              <a:t>3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B2100-0734-45BD-987A-45FB6FDA80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86183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ECB9C3-4A3F-4ECD-9596-22DD368FA6DE}" type="datetimeFigureOut">
              <a:rPr lang="en-US" smtClean="0"/>
              <a:t>3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B2100-0734-45BD-987A-45FB6FDA80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8267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ECB9C3-4A3F-4ECD-9596-22DD368FA6DE}" type="datetimeFigureOut">
              <a:rPr lang="en-US" smtClean="0"/>
              <a:t>3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B2100-0734-45BD-987A-45FB6FDA80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59381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ECB9C3-4A3F-4ECD-9596-22DD368FA6DE}" type="datetimeFigureOut">
              <a:rPr lang="en-US" smtClean="0"/>
              <a:t>3/2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B2100-0734-45BD-987A-45FB6FDA80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781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ECB9C3-4A3F-4ECD-9596-22DD368FA6DE}" type="datetimeFigureOut">
              <a:rPr lang="en-US" smtClean="0"/>
              <a:t>3/2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B2100-0734-45BD-987A-45FB6FDA80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68018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ECB9C3-4A3F-4ECD-9596-22DD368FA6DE}" type="datetimeFigureOut">
              <a:rPr lang="en-US" smtClean="0"/>
              <a:t>3/2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B2100-0734-45BD-987A-45FB6FDA80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1318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ECB9C3-4A3F-4ECD-9596-22DD368FA6DE}" type="datetimeFigureOut">
              <a:rPr lang="en-US" smtClean="0"/>
              <a:t>3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B2100-0734-45BD-987A-45FB6FDA80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71456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ECB9C3-4A3F-4ECD-9596-22DD368FA6DE}" type="datetimeFigureOut">
              <a:rPr lang="en-US" smtClean="0"/>
              <a:t>3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B2100-0734-45BD-987A-45FB6FDA80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88702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ECB9C3-4A3F-4ECD-9596-22DD368FA6DE}" type="datetimeFigureOut">
              <a:rPr lang="en-US" smtClean="0"/>
              <a:t>3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5B2100-0734-45BD-987A-45FB6FDA80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5903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13CE8A0B-BC17-4AF9-91DE-0F1C5A0186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2" name="Rectangle 2">
            <a:extLst>
              <a:ext uri="{FF2B5EF4-FFF2-40B4-BE49-F238E27FC236}">
                <a16:creationId xmlns:a16="http://schemas.microsoft.com/office/drawing/2014/main" id="{45CDF7A9-9DB8-43AA-9B08-14675E08C527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5" name="Picture 2">
            <a:extLst>
              <a:ext uri="{FF2B5EF4-FFF2-40B4-BE49-F238E27FC236}">
                <a16:creationId xmlns:a16="http://schemas.microsoft.com/office/drawing/2014/main" id="{A57241BF-61A0-4808-ABB1-6CC9F6AAF4C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9861" y="238539"/>
            <a:ext cx="7262191" cy="528159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3">
            <a:extLst>
              <a:ext uri="{FF2B5EF4-FFF2-40B4-BE49-F238E27FC236}">
                <a16:creationId xmlns:a16="http://schemas.microsoft.com/office/drawing/2014/main" id="{C469A34E-849B-42F6-B969-9A7D74B3798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95061" y="603636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.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unnel plot of publications on the association between coffee consumption and risk of lung cancer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242073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9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ma</dc:creator>
  <cp:lastModifiedBy>Kp</cp:lastModifiedBy>
  <cp:revision>7</cp:revision>
  <dcterms:created xsi:type="dcterms:W3CDTF">2022-02-07T13:30:41Z</dcterms:created>
  <dcterms:modified xsi:type="dcterms:W3CDTF">2024-03-22T08:15:19Z</dcterms:modified>
</cp:coreProperties>
</file>